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6" r:id="rId4"/>
    <p:sldId id="257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7" r:id="rId13"/>
    <p:sldId id="268" r:id="rId14"/>
    <p:sldId id="269" r:id="rId15"/>
    <p:sldId id="270" r:id="rId16"/>
    <p:sldId id="271" r:id="rId17"/>
    <p:sldId id="272" r:id="rId1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16" d="100"/>
          <a:sy n="116" d="100"/>
        </p:scale>
        <p:origin x="-108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DABF8-5777-4606-801B-20B1899B2105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356D0-4AC2-4C97-A754-FCA47C18B5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194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DABF8-5777-4606-801B-20B1899B2105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356D0-4AC2-4C97-A754-FCA47C18B5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468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DABF8-5777-4606-801B-20B1899B2105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356D0-4AC2-4C97-A754-FCA47C18B5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94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DABF8-5777-4606-801B-20B1899B2105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356D0-4AC2-4C97-A754-FCA47C18B5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0588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DABF8-5777-4606-801B-20B1899B2105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356D0-4AC2-4C97-A754-FCA47C18B5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917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DABF8-5777-4606-801B-20B1899B2105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356D0-4AC2-4C97-A754-FCA47C18B5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556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DABF8-5777-4606-801B-20B1899B2105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356D0-4AC2-4C97-A754-FCA47C18B5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61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DABF8-5777-4606-801B-20B1899B2105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356D0-4AC2-4C97-A754-FCA47C18B5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079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DABF8-5777-4606-801B-20B1899B2105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356D0-4AC2-4C97-A754-FCA47C18B5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939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DABF8-5777-4606-801B-20B1899B2105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356D0-4AC2-4C97-A754-FCA47C18B5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024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DABF8-5777-4606-801B-20B1899B2105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356D0-4AC2-4C97-A754-FCA47C18B5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783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DABF8-5777-4606-801B-20B1899B2105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5356D0-4AC2-4C97-A754-FCA47C18B5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304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IPA Analysis of Proteomics Data:</a:t>
            </a:r>
            <a:br>
              <a:rPr lang="en-US" dirty="0" smtClean="0"/>
            </a:br>
            <a:r>
              <a:rPr lang="en-US" dirty="0" smtClean="0"/>
              <a:t>Canonical Pathway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77500" lnSpcReduction="20000"/>
          </a:bodyPr>
          <a:lstStyle/>
          <a:p>
            <a:r>
              <a:rPr lang="en-US" u="sng" dirty="0" smtClean="0"/>
              <a:t>Supplement to paper: </a:t>
            </a:r>
            <a:r>
              <a:rPr lang="en-US" dirty="0" smtClean="0"/>
              <a:t>“Increased Hemodynamic Load in Early Embryonic Stages Alters Myofibril and Mitochondrial Organization in the Myocardium” by M. Midgett, C.S. Lopez, L. David, A. Maloyan and S. Rugony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81715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HIPPO </a:t>
            </a:r>
            <a:r>
              <a:rPr lang="en-US" dirty="0" err="1" smtClean="0"/>
              <a:t>Signling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7060" y="1600200"/>
            <a:ext cx="5349879" cy="4525963"/>
          </a:xfrm>
        </p:spPr>
      </p:pic>
    </p:spTree>
    <p:extLst>
      <p:ext uri="{BB962C8B-B14F-4D97-AF65-F5344CB8AC3E}">
        <p14:creationId xmlns:p14="http://schemas.microsoft.com/office/powerpoint/2010/main" val="50885073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Renin-Angiotensin Signaling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3359" y="1600200"/>
            <a:ext cx="3657282" cy="4525963"/>
          </a:xfrm>
        </p:spPr>
      </p:pic>
    </p:spTree>
    <p:extLst>
      <p:ext uri="{BB962C8B-B14F-4D97-AF65-F5344CB8AC3E}">
        <p14:creationId xmlns:p14="http://schemas.microsoft.com/office/powerpoint/2010/main" val="25725950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Other canonical pathways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ese are additional pathways mentioned in the manuscrip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093958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Mitochondrial Dysfunction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9405" y="1600200"/>
            <a:ext cx="7565189" cy="4525963"/>
          </a:xfrm>
        </p:spPr>
      </p:pic>
    </p:spTree>
    <p:extLst>
      <p:ext uri="{BB962C8B-B14F-4D97-AF65-F5344CB8AC3E}">
        <p14:creationId xmlns:p14="http://schemas.microsoft.com/office/powerpoint/2010/main" val="408665086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EIF2 Signaling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748" y="1600200"/>
            <a:ext cx="7142503" cy="4525963"/>
          </a:xfrm>
        </p:spPr>
      </p:pic>
    </p:spTree>
    <p:extLst>
      <p:ext uri="{BB962C8B-B14F-4D97-AF65-F5344CB8AC3E}">
        <p14:creationId xmlns:p14="http://schemas.microsoft.com/office/powerpoint/2010/main" val="141835205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Oxidative Phosphorylation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2265227"/>
            <a:ext cx="8229600" cy="3195908"/>
          </a:xfrm>
        </p:spPr>
      </p:pic>
    </p:spTree>
    <p:extLst>
      <p:ext uri="{BB962C8B-B14F-4D97-AF65-F5344CB8AC3E}">
        <p14:creationId xmlns:p14="http://schemas.microsoft.com/office/powerpoint/2010/main" val="404196520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JAK-STAT Pathway </a:t>
            </a:r>
            <a:endParaRPr lang="en-US" dirty="0"/>
          </a:p>
        </p:txBody>
      </p:sp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0352" y="1600200"/>
            <a:ext cx="6683295" cy="4525963"/>
          </a:xfrm>
        </p:spPr>
      </p:pic>
    </p:spTree>
    <p:extLst>
      <p:ext uri="{BB962C8B-B14F-4D97-AF65-F5344CB8AC3E}">
        <p14:creationId xmlns:p14="http://schemas.microsoft.com/office/powerpoint/2010/main" val="365955664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I3K-AKT Pathway 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4769" y="1600200"/>
            <a:ext cx="6074462" cy="4525963"/>
          </a:xfrm>
        </p:spPr>
      </p:pic>
    </p:spTree>
    <p:extLst>
      <p:ext uri="{BB962C8B-B14F-4D97-AF65-F5344CB8AC3E}">
        <p14:creationId xmlns:p14="http://schemas.microsoft.com/office/powerpoint/2010/main" val="34944443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b="1" dirty="0" smtClean="0"/>
              <a:t>TIPS FOR NAVIGATING THE PATHWAY SLIDES</a:t>
            </a:r>
            <a:endParaRPr lang="en-US" sz="3200" b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 smtClean="0"/>
              <a:t>In what follows pathway analysis by IPA is depicted graphically. Color code is as follows:</a:t>
            </a:r>
          </a:p>
          <a:p>
            <a:r>
              <a:rPr lang="en-US" dirty="0" smtClean="0"/>
              <a:t>Green: protein is downregulated in treated samples</a:t>
            </a:r>
          </a:p>
          <a:p>
            <a:r>
              <a:rPr lang="en-US" dirty="0" smtClean="0"/>
              <a:t>Pink: protein is upregulated in treated samples</a:t>
            </a:r>
          </a:p>
          <a:p>
            <a:r>
              <a:rPr lang="en-US" dirty="0" smtClean="0"/>
              <a:t>Grey: protein was detected but not significantly dysregulated in treated samples</a:t>
            </a:r>
          </a:p>
          <a:p>
            <a:r>
              <a:rPr lang="en-US" dirty="0" smtClean="0"/>
              <a:t>White: protein has not been detected by TMT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82197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Canonical pathways that were Significantly inhibited or activated due to banding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ese are pathways from </a:t>
            </a:r>
            <a:r>
              <a:rPr lang="en-US" smtClean="0"/>
              <a:t>Figure </a:t>
            </a:r>
            <a:r>
              <a:rPr lang="en-US" smtClean="0"/>
              <a:t>9 </a:t>
            </a:r>
            <a:r>
              <a:rPr lang="en-US" dirty="0" smtClean="0"/>
              <a:t>in the manuscrip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2110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Remodeling of Epithelial </a:t>
            </a:r>
            <a:r>
              <a:rPr lang="en-US" dirty="0" err="1" smtClean="0"/>
              <a:t>Adherens</a:t>
            </a:r>
            <a:r>
              <a:rPr lang="en-US" dirty="0" smtClean="0"/>
              <a:t> Junctions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3418" y="1600200"/>
            <a:ext cx="7117163" cy="4525963"/>
          </a:xfrm>
        </p:spPr>
      </p:pic>
    </p:spTree>
    <p:extLst>
      <p:ext uri="{BB962C8B-B14F-4D97-AF65-F5344CB8AC3E}">
        <p14:creationId xmlns:p14="http://schemas.microsoft.com/office/powerpoint/2010/main" val="20566889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Actin Nucleation by ARP-WASP Complex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3164" y="1600200"/>
            <a:ext cx="5837671" cy="4525963"/>
          </a:xfrm>
        </p:spPr>
      </p:pic>
    </p:spTree>
    <p:extLst>
      <p:ext uri="{BB962C8B-B14F-4D97-AF65-F5344CB8AC3E}">
        <p14:creationId xmlns:p14="http://schemas.microsoft.com/office/powerpoint/2010/main" val="35181501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onic Hedgehog Signaling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9926" y="1600200"/>
            <a:ext cx="6204147" cy="4525963"/>
          </a:xfrm>
        </p:spPr>
      </p:pic>
    </p:spTree>
    <p:extLst>
      <p:ext uri="{BB962C8B-B14F-4D97-AF65-F5344CB8AC3E}">
        <p14:creationId xmlns:p14="http://schemas.microsoft.com/office/powerpoint/2010/main" val="21597815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 smtClean="0"/>
              <a:t>Ephrin</a:t>
            </a:r>
            <a:r>
              <a:rPr lang="en-US" dirty="0" smtClean="0"/>
              <a:t> Receptor Signaling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557" y="1600200"/>
            <a:ext cx="6050886" cy="4525963"/>
          </a:xfrm>
        </p:spPr>
      </p:pic>
    </p:spTree>
    <p:extLst>
      <p:ext uri="{BB962C8B-B14F-4D97-AF65-F5344CB8AC3E}">
        <p14:creationId xmlns:p14="http://schemas.microsoft.com/office/powerpoint/2010/main" val="10118969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Leptin Signaling in Obesity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7514" y="1600200"/>
            <a:ext cx="6688971" cy="4525963"/>
          </a:xfrm>
        </p:spPr>
      </p:pic>
    </p:spTree>
    <p:extLst>
      <p:ext uri="{BB962C8B-B14F-4D97-AF65-F5344CB8AC3E}">
        <p14:creationId xmlns:p14="http://schemas.microsoft.com/office/powerpoint/2010/main" val="11146729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IGF-1 Signaling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1766" y="1600200"/>
            <a:ext cx="6540467" cy="4525963"/>
          </a:xfrm>
        </p:spPr>
      </p:pic>
    </p:spTree>
    <p:extLst>
      <p:ext uri="{BB962C8B-B14F-4D97-AF65-F5344CB8AC3E}">
        <p14:creationId xmlns:p14="http://schemas.microsoft.com/office/powerpoint/2010/main" val="39126887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56</TotalTime>
  <Words>169</Words>
  <Application>Microsoft Office PowerPoint</Application>
  <PresentationFormat>On-screen Show (4:3)</PresentationFormat>
  <Paragraphs>25</Paragraphs>
  <Slides>1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18" baseType="lpstr">
      <vt:lpstr>Office Theme</vt:lpstr>
      <vt:lpstr> IPA Analysis of Proteomics Data: Canonical Pathways</vt:lpstr>
      <vt:lpstr>TIPS FOR NAVIGATING THE PATHWAY SLIDES</vt:lpstr>
      <vt:lpstr>Canonical pathways that were Significantly inhibited or activated due to banding</vt:lpstr>
      <vt:lpstr>Remodeling of Epithelial Adherens Junctions</vt:lpstr>
      <vt:lpstr>Actin Nucleation by ARP-WASP Complex</vt:lpstr>
      <vt:lpstr>Sonic Hedgehog Signaling</vt:lpstr>
      <vt:lpstr>Ephrin Receptor Signaling</vt:lpstr>
      <vt:lpstr>Leptin Signaling in Obesity</vt:lpstr>
      <vt:lpstr>IGF-1 Signaling</vt:lpstr>
      <vt:lpstr>HIPPO Signling</vt:lpstr>
      <vt:lpstr>Renin-Angiotensin Signaling</vt:lpstr>
      <vt:lpstr>Other canonical pathways</vt:lpstr>
      <vt:lpstr>Mitochondrial Dysfunction</vt:lpstr>
      <vt:lpstr>EIF2 Signaling</vt:lpstr>
      <vt:lpstr>Oxidative Phosphorylation</vt:lpstr>
      <vt:lpstr>JAK-STAT Pathway </vt:lpstr>
      <vt:lpstr>PI3K-AKT Pathway </vt:lpstr>
    </vt:vector>
  </TitlesOfParts>
  <Company>OHS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nonical Pathways</dc:title>
  <dc:creator>Sandra Rugonyi</dc:creator>
  <cp:lastModifiedBy>Sandra Rugonyi</cp:lastModifiedBy>
  <cp:revision>10</cp:revision>
  <dcterms:created xsi:type="dcterms:W3CDTF">2017-07-14T22:07:32Z</dcterms:created>
  <dcterms:modified xsi:type="dcterms:W3CDTF">2017-08-21T20:10:02Z</dcterms:modified>
</cp:coreProperties>
</file>